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521AAF-D0A5-471B-AB2A-4B878700C9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68D7D80-3A21-46F4-ABA4-C207FCDE53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B04063-0143-4401-AF85-9C746A16E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19A0426-B7EE-4562-A266-26F300EC8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1E37DD-A18A-42BC-A267-20A3A8931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95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161C8A-2A7D-42D4-A118-0E161E3838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52A9ED7-80C3-4E28-B9A4-C1BC85840C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42864C-C2E0-4A29-B3D5-D9564E9C6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169F4D1-70BB-4F7D-BC76-3E8F8CFC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D6FAA4-7D49-4741-A9F6-0A9935D06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3060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ED50870-3898-4BDB-9347-AFD4472290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AC44191-EED9-4FEF-B8F8-11A9301303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19FBD3-37B3-4037-9A4B-247BE8328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512FB6-C19C-42EF-8A20-76671BFE9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03CAF1-A8C2-4BFC-82B1-F414B679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020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AC1358-C278-486D-96A7-D7EE26781E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B596B36-DC6C-4128-81F4-B8CC924323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106111-F22D-4E93-A27C-1718BE0D1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FF742F-7B50-4ED5-9FAA-4B470C075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43246A-876F-4FA2-8B81-0396A14D4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1170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C9FE43-D367-4BF1-9199-F3CAE9F19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6429400-4781-49AB-B003-F9901C3564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4357CC-B8B8-4DD9-AC1F-57D3E3E2C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E35705-77CF-44DE-9734-F1AD9868D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FE17C0-0132-4DF8-A152-A482BA16F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7751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BC4F63-A95C-4033-87B1-5AA8096BEA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D1C2DD-ECE2-4E52-A293-17936AEF51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56822AF-1F00-4EC6-AE9C-F7C3337BD6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3FB725F-99DA-4F9D-ACF6-99707CE02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87D1B0E-A8E6-4B14-A7BE-C90A670C5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9E4A7EB-713A-48B1-A22D-27465DDB3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604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50D42C-811D-4762-AE25-D3AF02AAEC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C1844C-D363-4265-9552-2E8A188A35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03EEEC3-6FF1-4595-BCC0-6DF7F17113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37C7D48-D5BA-499B-96DA-FF6EF24061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DA08F2B-20F9-4FC2-9B4E-1B22F35A1D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B20E279-CD23-4EF9-A3D8-3B8D911A7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7A81EB6-909A-455F-A59E-70E3A871B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266D316-4F8D-456E-985A-06BAF752E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022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575DAC-2DD0-4008-B087-E374FFA3E0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C117E92-F529-4843-BFFA-8FBB65A21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8A723E4-535C-4B92-8BB4-52AE3C8FA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17923EC-C2CC-457C-9819-6BCFA82BF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7855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7EC8F30-7F17-4408-BD44-A4E27E4AF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52BB490-E49F-45E1-9F0C-2532D6F80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0D3576E-DB4A-4570-BF0D-704CA8317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544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8AB86E-44CE-4EFD-A5CD-CC8E746B29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407EF18-F398-4163-ABE5-3503D99BC3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C979A3C-23BA-4E66-A64A-F12F1BC682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986307-833A-4E86-AC7B-FCC5C6B39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7E7E5D-048C-47AE-83F4-EF7266643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7EC1F4-8E73-4482-AB71-45F243332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644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B84D41-B384-4320-9E37-871EB74527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0988792-D6A9-4C60-BA5C-EC95425DEF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237948-C344-4DD1-A290-9B4F12367C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46CA909-7BFC-4C95-881A-20248B225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2C32CB3-4FA8-423E-8579-D6C8E8994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5325EF-82A4-450C-BE8A-25C9E318C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557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B5F9837-67C5-4C40-993C-F02DBA4D26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5F5FDC4-8FCA-49ED-8D4A-C6E156640B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5AFEDC-718E-45EE-B5C0-A85AC523FB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E4E78E-D98B-4635-B2C6-720BB4F766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5CF415-1A74-4B42-9FC0-5B91978A79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858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2126569"/>
              </p:ext>
            </p:extLst>
          </p:nvPr>
        </p:nvGraphicFramePr>
        <p:xfrm>
          <a:off x="157477" y="333580"/>
          <a:ext cx="7140469" cy="1173480"/>
        </p:xfrm>
        <a:graphic>
          <a:graphicData uri="http://schemas.openxmlformats.org/drawingml/2006/table">
            <a:tbl>
              <a:tblPr firstRow="1" firstCol="1" bandRow="1"/>
              <a:tblGrid>
                <a:gridCol w="1365875">
                  <a:extLst>
                    <a:ext uri="{9D8B030D-6E8A-4147-A177-3AD203B41FA5}">
                      <a16:colId xmlns:a16="http://schemas.microsoft.com/office/drawing/2014/main" val="358794847"/>
                    </a:ext>
                  </a:extLst>
                </a:gridCol>
                <a:gridCol w="5774594">
                  <a:extLst>
                    <a:ext uri="{9D8B030D-6E8A-4147-A177-3AD203B41FA5}">
                      <a16:colId xmlns:a16="http://schemas.microsoft.com/office/drawing/2014/main" val="1378919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ontent of Question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Have you consumed following protein</a:t>
                      </a:r>
                      <a:r>
                        <a:rPr lang="ja-JP" alt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100" kern="0" dirty="0"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ource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in the past four weeks?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78858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7;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lmost every day,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4.5;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4-5 times a week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2.5;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-3 times a week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1;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Once a week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0;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1077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rotein item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at, Fish, Eggs, </a:t>
                      </a:r>
                      <a:r>
                        <a:rPr lang="en-US" sz="1100" kern="0" dirty="0"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US" altLang="ja-JP" sz="1100" kern="0" dirty="0"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oy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ofu, natto, etc.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), Dairy products (milk, yoghurt, cheese, etc.)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7054002"/>
                  </a:ext>
                </a:extLst>
              </a:tr>
            </a:tbl>
          </a:graphicData>
        </a:graphic>
      </p:graphicFrame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94747" y="71970"/>
            <a:ext cx="4358886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100" b="1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Table S2. </a:t>
            </a:r>
            <a:r>
              <a:rPr kumimoji="0" lang="en-US" altLang="ja-JP" sz="1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ntent of question about weekly protein intake.</a:t>
            </a:r>
          </a:p>
        </p:txBody>
      </p:sp>
    </p:spTree>
    <p:extLst>
      <p:ext uri="{BB962C8B-B14F-4D97-AF65-F5344CB8AC3E}">
        <p14:creationId xmlns:p14="http://schemas.microsoft.com/office/powerpoint/2010/main" val="1999438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0</TotalTime>
  <Words>84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bata shigenobu</dc:creator>
  <cp:lastModifiedBy>MDPI</cp:lastModifiedBy>
  <cp:revision>40</cp:revision>
  <cp:lastPrinted>2022-06-15T02:16:55Z</cp:lastPrinted>
  <dcterms:created xsi:type="dcterms:W3CDTF">2021-12-25T05:48:07Z</dcterms:created>
  <dcterms:modified xsi:type="dcterms:W3CDTF">2022-12-06T02:57:12Z</dcterms:modified>
</cp:coreProperties>
</file>